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462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959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319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162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163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686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47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116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126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392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53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1100C-2873-4E5B-A3CC-D5DD490DF539}" type="datetimeFigureOut">
              <a:rPr lang="en-US" smtClean="0"/>
              <a:t>8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EDFA7B-83CC-42FD-8896-FA87F5994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6882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639"/>
          <a:stretch/>
        </p:blipFill>
        <p:spPr>
          <a:xfrm>
            <a:off x="1582826" y="680978"/>
            <a:ext cx="9714170" cy="5874679"/>
          </a:xfrm>
          <a:prstGeom prst="rect">
            <a:avLst/>
          </a:prstGeom>
        </p:spPr>
      </p:pic>
      <p:grpSp>
        <p:nvGrpSpPr>
          <p:cNvPr id="61" name="Group 60"/>
          <p:cNvGrpSpPr/>
          <p:nvPr/>
        </p:nvGrpSpPr>
        <p:grpSpPr>
          <a:xfrm>
            <a:off x="2015550" y="224015"/>
            <a:ext cx="8763323" cy="1765093"/>
            <a:chOff x="2015550" y="224015"/>
            <a:chExt cx="8763323" cy="1765093"/>
          </a:xfrm>
        </p:grpSpPr>
        <p:grpSp>
          <p:nvGrpSpPr>
            <p:cNvPr id="5" name="Group 4"/>
            <p:cNvGrpSpPr/>
            <p:nvPr/>
          </p:nvGrpSpPr>
          <p:grpSpPr>
            <a:xfrm>
              <a:off x="2143216" y="1363175"/>
              <a:ext cx="4056411" cy="264754"/>
              <a:chOff x="2143216" y="1363175"/>
              <a:chExt cx="4056411" cy="264754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2143216" y="1366319"/>
                <a:ext cx="6400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299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586143" y="1366319"/>
                <a:ext cx="7315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48Q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054649" y="1366319"/>
                <a:ext cx="7315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82W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549001" y="1364747"/>
                <a:ext cx="7315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175H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626216" y="1366319"/>
                <a:ext cx="7382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155000" y="1366319"/>
                <a:ext cx="6400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73H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058266" y="1363175"/>
                <a:ext cx="6400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45S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468107" y="1363175"/>
                <a:ext cx="7315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49S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6080546" y="1360031"/>
              <a:ext cx="4056411" cy="264754"/>
              <a:chOff x="2143216" y="1363175"/>
              <a:chExt cx="4056411" cy="264754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2143216" y="1366319"/>
                <a:ext cx="6400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299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586143" y="1366319"/>
                <a:ext cx="7315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48Q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054649" y="1366319"/>
                <a:ext cx="7315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82W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549001" y="1364747"/>
                <a:ext cx="7315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175H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626216" y="1366319"/>
                <a:ext cx="73825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155000" y="1366319"/>
                <a:ext cx="6400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73H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058266" y="1363175"/>
                <a:ext cx="6400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45S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468107" y="1363175"/>
                <a:ext cx="7315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249S</a:t>
                </a:r>
                <a:endPara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2189585" y="1588496"/>
              <a:ext cx="4012771" cy="307777"/>
              <a:chOff x="2568074" y="223149"/>
              <a:chExt cx="4012771" cy="307777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2568074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2810654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3056044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298625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3544019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769973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015365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4274571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532866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742194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004210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230165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5493063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5719020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5965286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6207866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6069298" y="1588495"/>
              <a:ext cx="4012771" cy="307777"/>
              <a:chOff x="2568074" y="223149"/>
              <a:chExt cx="4012771" cy="307777"/>
            </a:xfrm>
          </p:grpSpPr>
          <p:sp>
            <p:nvSpPr>
              <p:cNvPr id="41" name="TextBox 40"/>
              <p:cNvSpPr txBox="1"/>
              <p:nvPr/>
            </p:nvSpPr>
            <p:spPr>
              <a:xfrm>
                <a:off x="2568074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810654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3056044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3298625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3544019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769973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4015365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4274571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4532866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4742194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5004210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5230165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5493063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5719020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5965286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6207866" y="223149"/>
                <a:ext cx="3729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7" name="TextBox 56"/>
            <p:cNvSpPr txBox="1"/>
            <p:nvPr/>
          </p:nvSpPr>
          <p:spPr>
            <a:xfrm rot="16200000">
              <a:off x="1263808" y="975757"/>
              <a:ext cx="176509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 protein loading control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0003076" y="1638027"/>
              <a:ext cx="7757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astin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9" name="Straight Connector 58"/>
            <p:cNvCxnSpPr/>
            <p:nvPr/>
          </p:nvCxnSpPr>
          <p:spPr>
            <a:xfrm>
              <a:off x="6255787" y="1246909"/>
              <a:ext cx="363979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7361937" y="899152"/>
              <a:ext cx="14274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4% 2-ME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2298689" y="1569740"/>
            <a:ext cx="7649915" cy="0"/>
            <a:chOff x="2298689" y="1569740"/>
            <a:chExt cx="7649915" cy="0"/>
          </a:xfrm>
        </p:grpSpPr>
        <p:cxnSp>
          <p:nvCxnSpPr>
            <p:cNvPr id="63" name="Straight Connector 62"/>
            <p:cNvCxnSpPr/>
            <p:nvPr/>
          </p:nvCxnSpPr>
          <p:spPr>
            <a:xfrm>
              <a:off x="2298689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>
              <a:off x="2835325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332177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378234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428262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4749521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5213534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5685560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1" name="Group 70"/>
            <p:cNvGrpSpPr/>
            <p:nvPr/>
          </p:nvGrpSpPr>
          <p:grpSpPr>
            <a:xfrm>
              <a:off x="6241693" y="1569740"/>
              <a:ext cx="3706911" cy="0"/>
              <a:chOff x="6241693" y="1569740"/>
              <a:chExt cx="3706911" cy="0"/>
            </a:xfrm>
          </p:grpSpPr>
          <p:cxnSp>
            <p:nvCxnSpPr>
              <p:cNvPr id="72" name="Straight Connector 71"/>
              <p:cNvCxnSpPr/>
              <p:nvPr/>
            </p:nvCxnSpPr>
            <p:spPr>
              <a:xfrm>
                <a:off x="6241693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6778329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>
                <a:off x="726478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/>
              <p:cNvCxnSpPr/>
              <p:nvPr/>
            </p:nvCxnSpPr>
            <p:spPr>
              <a:xfrm>
                <a:off x="772535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/>
              <p:nvPr/>
            </p:nvCxnSpPr>
            <p:spPr>
              <a:xfrm>
                <a:off x="822563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/>
              <p:nvPr/>
            </p:nvCxnSpPr>
            <p:spPr>
              <a:xfrm>
                <a:off x="8692525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9156538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9628564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0" name="TextBox 79"/>
          <p:cNvSpPr txBox="1"/>
          <p:nvPr/>
        </p:nvSpPr>
        <p:spPr>
          <a:xfrm>
            <a:off x="9939287" y="2162194"/>
            <a:ext cx="83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P1/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0208066" y="3341318"/>
            <a:ext cx="99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ee prob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9405437" y="5256017"/>
            <a:ext cx="13734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curv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3919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642"/>
          <a:stretch/>
        </p:blipFill>
        <p:spPr>
          <a:xfrm>
            <a:off x="1031938" y="349546"/>
            <a:ext cx="9990737" cy="6284009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2143216" y="1014040"/>
            <a:ext cx="4056411" cy="264754"/>
            <a:chOff x="2143216" y="1363175"/>
            <a:chExt cx="4056411" cy="264754"/>
          </a:xfrm>
        </p:grpSpPr>
        <p:sp>
          <p:nvSpPr>
            <p:cNvPr id="4" name="TextBox 3"/>
            <p:cNvSpPr txBox="1"/>
            <p:nvPr/>
          </p:nvSpPr>
          <p:spPr>
            <a:xfrm>
              <a:off x="2143216" y="1366319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299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586143" y="1366319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8Q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054649" y="1366319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82W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549001" y="1364747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175H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626216" y="1366319"/>
              <a:ext cx="7382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55000" y="1366319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73H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058266" y="1363175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5S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468107" y="1363175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9S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2298689" y="1220605"/>
            <a:ext cx="7649915" cy="0"/>
            <a:chOff x="2298689" y="1569740"/>
            <a:chExt cx="7649915" cy="0"/>
          </a:xfrm>
        </p:grpSpPr>
        <p:cxnSp>
          <p:nvCxnSpPr>
            <p:cNvPr id="13" name="Straight Connector 12"/>
            <p:cNvCxnSpPr/>
            <p:nvPr/>
          </p:nvCxnSpPr>
          <p:spPr>
            <a:xfrm>
              <a:off x="2298689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2835325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332177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378234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428262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4749521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5213534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5685560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oup 20"/>
            <p:cNvGrpSpPr/>
            <p:nvPr/>
          </p:nvGrpSpPr>
          <p:grpSpPr>
            <a:xfrm>
              <a:off x="6241693" y="1569740"/>
              <a:ext cx="3706911" cy="0"/>
              <a:chOff x="6241693" y="1569740"/>
              <a:chExt cx="3706911" cy="0"/>
            </a:xfrm>
          </p:grpSpPr>
          <p:cxnSp>
            <p:nvCxnSpPr>
              <p:cNvPr id="22" name="Straight Connector 21"/>
              <p:cNvCxnSpPr/>
              <p:nvPr/>
            </p:nvCxnSpPr>
            <p:spPr>
              <a:xfrm>
                <a:off x="6241693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>
                <a:off x="6778329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726478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>
                <a:off x="772535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>
                <a:off x="822563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>
                <a:off x="8692525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9156538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9628564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0" name="Group 29"/>
          <p:cNvGrpSpPr/>
          <p:nvPr/>
        </p:nvGrpSpPr>
        <p:grpSpPr>
          <a:xfrm>
            <a:off x="2189585" y="1239362"/>
            <a:ext cx="4012771" cy="307777"/>
            <a:chOff x="2568074" y="223149"/>
            <a:chExt cx="4012771" cy="307777"/>
          </a:xfrm>
        </p:grpSpPr>
        <p:sp>
          <p:nvSpPr>
            <p:cNvPr id="31" name="TextBox 30"/>
            <p:cNvSpPr txBox="1"/>
            <p:nvPr/>
          </p:nvSpPr>
          <p:spPr>
            <a:xfrm>
              <a:off x="256807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81065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05604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29862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544019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769973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01536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274571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53286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74219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004210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23016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5493063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719020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96528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620786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6069298" y="1239360"/>
            <a:ext cx="4012771" cy="307777"/>
            <a:chOff x="2568074" y="223149"/>
            <a:chExt cx="4012771" cy="307777"/>
          </a:xfrm>
        </p:grpSpPr>
        <p:sp>
          <p:nvSpPr>
            <p:cNvPr id="48" name="TextBox 47"/>
            <p:cNvSpPr txBox="1"/>
            <p:nvPr/>
          </p:nvSpPr>
          <p:spPr>
            <a:xfrm>
              <a:off x="256807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81065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05604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29862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544019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769973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01536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274571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53286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74219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004210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523016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5493063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5719020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96528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620786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4" name="TextBox 63"/>
          <p:cNvSpPr txBox="1"/>
          <p:nvPr/>
        </p:nvSpPr>
        <p:spPr>
          <a:xfrm rot="16200000">
            <a:off x="1263808" y="975757"/>
            <a:ext cx="17650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protein loading control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0003076" y="1638027"/>
            <a:ext cx="775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7361937" y="550017"/>
            <a:ext cx="14274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4% 2-ME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7" name="Group 66"/>
          <p:cNvGrpSpPr/>
          <p:nvPr/>
        </p:nvGrpSpPr>
        <p:grpSpPr>
          <a:xfrm>
            <a:off x="6080546" y="1010896"/>
            <a:ext cx="4056411" cy="264754"/>
            <a:chOff x="2143216" y="1363175"/>
            <a:chExt cx="4056411" cy="264754"/>
          </a:xfrm>
        </p:grpSpPr>
        <p:sp>
          <p:nvSpPr>
            <p:cNvPr id="68" name="TextBox 67"/>
            <p:cNvSpPr txBox="1"/>
            <p:nvPr/>
          </p:nvSpPr>
          <p:spPr>
            <a:xfrm>
              <a:off x="2143216" y="1366319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299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3586143" y="1366319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8Q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054649" y="1366319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82W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549001" y="1364747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175H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2626216" y="1366319"/>
              <a:ext cx="7382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155000" y="1366319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73H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058266" y="1363175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5S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468107" y="1363175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9S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76" name="Straight Connector 75"/>
          <p:cNvCxnSpPr/>
          <p:nvPr/>
        </p:nvCxnSpPr>
        <p:spPr>
          <a:xfrm>
            <a:off x="6255787" y="989214"/>
            <a:ext cx="36397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9939287" y="2162194"/>
            <a:ext cx="83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P1/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9982272" y="3313716"/>
            <a:ext cx="99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ee prob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9672362" y="4961895"/>
            <a:ext cx="13734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curv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81943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15"/>
          <a:stretch/>
        </p:blipFill>
        <p:spPr>
          <a:xfrm>
            <a:off x="428514" y="124691"/>
            <a:ext cx="10058400" cy="6247564"/>
          </a:xfrm>
          <a:prstGeom prst="rect">
            <a:avLst/>
          </a:prstGeom>
        </p:spPr>
      </p:pic>
      <p:grpSp>
        <p:nvGrpSpPr>
          <p:cNvPr id="33" name="Group 32"/>
          <p:cNvGrpSpPr/>
          <p:nvPr/>
        </p:nvGrpSpPr>
        <p:grpSpPr>
          <a:xfrm>
            <a:off x="2143216" y="1363175"/>
            <a:ext cx="4056411" cy="264754"/>
            <a:chOff x="2143216" y="1363175"/>
            <a:chExt cx="4056411" cy="264754"/>
          </a:xfrm>
        </p:grpSpPr>
        <p:sp>
          <p:nvSpPr>
            <p:cNvPr id="6" name="TextBox 5"/>
            <p:cNvSpPr txBox="1"/>
            <p:nvPr/>
          </p:nvSpPr>
          <p:spPr>
            <a:xfrm>
              <a:off x="2143216" y="1366319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299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586143" y="1366319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8Q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054649" y="1366319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82W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49001" y="1364747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175H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626216" y="1366319"/>
              <a:ext cx="7382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155000" y="1366319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73H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058266" y="1363175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5S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468107" y="1363175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9S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2298689" y="1569740"/>
            <a:ext cx="7649915" cy="0"/>
            <a:chOff x="2298689" y="1569740"/>
            <a:chExt cx="7649915" cy="0"/>
          </a:xfrm>
        </p:grpSpPr>
        <p:cxnSp>
          <p:nvCxnSpPr>
            <p:cNvPr id="15" name="Straight Connector 14"/>
            <p:cNvCxnSpPr/>
            <p:nvPr/>
          </p:nvCxnSpPr>
          <p:spPr>
            <a:xfrm>
              <a:off x="2298689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2835325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332177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378234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4282628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4749521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5213534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5685560" y="1569740"/>
              <a:ext cx="32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" name="Group 30"/>
            <p:cNvGrpSpPr/>
            <p:nvPr/>
          </p:nvGrpSpPr>
          <p:grpSpPr>
            <a:xfrm>
              <a:off x="6241693" y="1569740"/>
              <a:ext cx="3706911" cy="0"/>
              <a:chOff x="6241693" y="1569740"/>
              <a:chExt cx="3706911" cy="0"/>
            </a:xfrm>
          </p:grpSpPr>
          <p:cxnSp>
            <p:nvCxnSpPr>
              <p:cNvPr id="23" name="Straight Connector 22"/>
              <p:cNvCxnSpPr/>
              <p:nvPr/>
            </p:nvCxnSpPr>
            <p:spPr>
              <a:xfrm>
                <a:off x="6241693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6778329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>
                <a:off x="726478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>
                <a:off x="772535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>
              <a:xfrm>
                <a:off x="8225632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8692525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9156538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>
                <a:off x="9628564" y="1569740"/>
                <a:ext cx="32004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4" name="Group 33"/>
          <p:cNvGrpSpPr/>
          <p:nvPr/>
        </p:nvGrpSpPr>
        <p:grpSpPr>
          <a:xfrm>
            <a:off x="6080546" y="1360031"/>
            <a:ext cx="4056411" cy="264754"/>
            <a:chOff x="2143216" y="1363175"/>
            <a:chExt cx="4056411" cy="264754"/>
          </a:xfrm>
        </p:grpSpPr>
        <p:sp>
          <p:nvSpPr>
            <p:cNvPr id="35" name="TextBox 34"/>
            <p:cNvSpPr txBox="1"/>
            <p:nvPr/>
          </p:nvSpPr>
          <p:spPr>
            <a:xfrm>
              <a:off x="2143216" y="1366319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299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586143" y="1366319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8Q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054649" y="1366319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82W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549001" y="1364747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175H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626216" y="1366319"/>
              <a:ext cx="7382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155000" y="1366319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73H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058266" y="1363175"/>
              <a:ext cx="6400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5S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468107" y="1363175"/>
              <a:ext cx="731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249S</a:t>
              </a:r>
              <a:endPara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2189585" y="1588497"/>
            <a:ext cx="4012771" cy="307777"/>
            <a:chOff x="2568074" y="223149"/>
            <a:chExt cx="4012771" cy="307777"/>
          </a:xfrm>
        </p:grpSpPr>
        <p:sp>
          <p:nvSpPr>
            <p:cNvPr id="44" name="TextBox 43"/>
            <p:cNvSpPr txBox="1"/>
            <p:nvPr/>
          </p:nvSpPr>
          <p:spPr>
            <a:xfrm>
              <a:off x="256807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81065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05604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29862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544019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769973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01536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274571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53286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4219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004210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23016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493063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719020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96528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620786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6069298" y="1588495"/>
            <a:ext cx="4012771" cy="307777"/>
            <a:chOff x="2568074" y="223149"/>
            <a:chExt cx="4012771" cy="307777"/>
          </a:xfrm>
        </p:grpSpPr>
        <p:sp>
          <p:nvSpPr>
            <p:cNvPr id="61" name="TextBox 60"/>
            <p:cNvSpPr txBox="1"/>
            <p:nvPr/>
          </p:nvSpPr>
          <p:spPr>
            <a:xfrm>
              <a:off x="256807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81065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05604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29862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544019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769973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01536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274571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53286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742194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5004210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230165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493063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719020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96528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6207866" y="223149"/>
              <a:ext cx="3729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7" name="TextBox 76"/>
          <p:cNvSpPr txBox="1"/>
          <p:nvPr/>
        </p:nvSpPr>
        <p:spPr>
          <a:xfrm rot="16200000">
            <a:off x="1263808" y="975757"/>
            <a:ext cx="17650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protein loading control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0003076" y="1638027"/>
            <a:ext cx="775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astin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>
            <a:off x="6255787" y="1246909"/>
            <a:ext cx="363979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7361937" y="899152"/>
            <a:ext cx="14274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4% 2-ME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9939287" y="2162194"/>
            <a:ext cx="83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RP1/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0003076" y="3010748"/>
            <a:ext cx="99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ee prob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9778571" y="5771406"/>
            <a:ext cx="13734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ndard curv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1831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93BF79B885EBB49B491F1663C226B4C" ma:contentTypeVersion="12" ma:contentTypeDescription="Create a new document." ma:contentTypeScope="" ma:versionID="07cf0b7a56b585a4ff396fb5261da5fd">
  <xsd:schema xmlns:xsd="http://www.w3.org/2001/XMLSchema" xmlns:xs="http://www.w3.org/2001/XMLSchema" xmlns:p="http://schemas.microsoft.com/office/2006/metadata/properties" xmlns:ns3="ef549723-c3fb-4966-bf14-ad4d081bfc97" xmlns:ns4="3d0828cf-833c-4cd6-9d60-ea5acd20918d" targetNamespace="http://schemas.microsoft.com/office/2006/metadata/properties" ma:root="true" ma:fieldsID="e502bdc0e8564bc06803b1849965f9b2" ns3:_="" ns4:_="">
    <xsd:import namespace="ef549723-c3fb-4966-bf14-ad4d081bfc97"/>
    <xsd:import namespace="3d0828cf-833c-4cd6-9d60-ea5acd20918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DateTaken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f549723-c3fb-4966-bf14-ad4d081bfc9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d0828cf-833c-4cd6-9d60-ea5acd20918d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4193323-D422-4AD8-AD0D-EC0275601C1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f549723-c3fb-4966-bf14-ad4d081bfc97"/>
    <ds:schemaRef ds:uri="3d0828cf-833c-4cd6-9d60-ea5acd20918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405C4AD-440A-49A6-A354-DF4DDCD6433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7D8A69B-C790-4462-B586-7B1BC408855E}">
  <ds:schemaRefs>
    <ds:schemaRef ds:uri="http://schemas.microsoft.com/office/2006/documentManagement/types"/>
    <ds:schemaRef ds:uri="http://purl.org/dc/dcmitype/"/>
    <ds:schemaRef ds:uri="http://schemas.microsoft.com/office/2006/metadata/properties"/>
    <ds:schemaRef ds:uri="http://purl.org/dc/elements/1.1/"/>
    <ds:schemaRef ds:uri="http://purl.org/dc/terms/"/>
    <ds:schemaRef ds:uri="http://schemas.microsoft.com/office/infopath/2007/PartnerControls"/>
    <ds:schemaRef ds:uri="ef549723-c3fb-4966-bf14-ad4d081bfc97"/>
    <ds:schemaRef ds:uri="http://schemas.openxmlformats.org/package/2006/metadata/core-properties"/>
    <ds:schemaRef ds:uri="3d0828cf-833c-4cd6-9d60-ea5acd20918d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86</Words>
  <Application>Microsoft Office PowerPoint</Application>
  <PresentationFormat>Widescreen</PresentationFormat>
  <Paragraphs>16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Oklahoma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tgomery, Mckale</dc:creator>
  <cp:lastModifiedBy>Montgomery, Mckale</cp:lastModifiedBy>
  <cp:revision>7</cp:revision>
  <dcterms:created xsi:type="dcterms:W3CDTF">2020-08-12T20:21:59Z</dcterms:created>
  <dcterms:modified xsi:type="dcterms:W3CDTF">2020-08-12T20:46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93BF79B885EBB49B491F1663C226B4C</vt:lpwstr>
  </property>
</Properties>
</file>